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41" r:id="rId2"/>
    <p:sldId id="34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EEE54D-BADB-2632-794F-3B80CAF51590}" name="Gourapura, Aradhya" initials="AG" userId="S::gourapura.1@osu.edu::f08648d5-c116-438b-b177-bced89d1faa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86" autoAdjust="0"/>
    <p:restoredTop sz="94660"/>
  </p:normalViewPr>
  <p:slideViewPr>
    <p:cSldViewPr snapToGrid="0">
      <p:cViewPr varScale="1">
        <p:scale>
          <a:sx n="99" d="100"/>
          <a:sy n="99" d="100"/>
        </p:scale>
        <p:origin x="94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4" d="100"/>
        <a:sy n="104" d="100"/>
      </p:scale>
      <p:origin x="0" y="-21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urapura, Aradhya" userId="f08648d5-c116-438b-b177-bced89d1faa8" providerId="ADAL" clId="{699B68FE-8C20-41D9-9674-1A0C3A8E476B}"/>
    <pc:docChg chg="delSld modSld">
      <pc:chgData name="Gourapura, Aradhya" userId="f08648d5-c116-438b-b177-bced89d1faa8" providerId="ADAL" clId="{699B68FE-8C20-41D9-9674-1A0C3A8E476B}" dt="2025-01-24T17:48:14.517" v="12" actId="6549"/>
      <pc:docMkLst>
        <pc:docMk/>
      </pc:docMkLst>
      <pc:sldChg chg="del">
        <pc:chgData name="Gourapura, Aradhya" userId="f08648d5-c116-438b-b177-bced89d1faa8" providerId="ADAL" clId="{699B68FE-8C20-41D9-9674-1A0C3A8E476B}" dt="2025-01-24T17:05:31.280" v="2" actId="47"/>
        <pc:sldMkLst>
          <pc:docMk/>
          <pc:sldMk cId="1842536160" sldId="256"/>
        </pc:sldMkLst>
      </pc:sldChg>
      <pc:sldChg chg="modSp mod">
        <pc:chgData name="Gourapura, Aradhya" userId="f08648d5-c116-438b-b177-bced89d1faa8" providerId="ADAL" clId="{699B68FE-8C20-41D9-9674-1A0C3A8E476B}" dt="2025-01-24T17:48:14.517" v="12" actId="6549"/>
        <pc:sldMkLst>
          <pc:docMk/>
          <pc:sldMk cId="2981433442" sldId="341"/>
        </pc:sldMkLst>
        <pc:spChg chg="mod">
          <ac:chgData name="Gourapura, Aradhya" userId="f08648d5-c116-438b-b177-bced89d1faa8" providerId="ADAL" clId="{699B68FE-8C20-41D9-9674-1A0C3A8E476B}" dt="2025-01-24T17:48:14.517" v="12" actId="6549"/>
          <ac:spMkLst>
            <pc:docMk/>
            <pc:sldMk cId="2981433442" sldId="341"/>
            <ac:spMk id="8" creationId="{316F96AE-952D-5F35-44CE-AD45DBA766F7}"/>
          </ac:spMkLst>
        </pc:spChg>
      </pc:sldChg>
      <pc:sldChg chg="del">
        <pc:chgData name="Gourapura, Aradhya" userId="f08648d5-c116-438b-b177-bced89d1faa8" providerId="ADAL" clId="{699B68FE-8C20-41D9-9674-1A0C3A8E476B}" dt="2025-01-24T17:05:24.510" v="0" actId="47"/>
        <pc:sldMkLst>
          <pc:docMk/>
          <pc:sldMk cId="1934611800" sldId="342"/>
        </pc:sldMkLst>
      </pc:sldChg>
      <pc:sldChg chg="del">
        <pc:chgData name="Gourapura, Aradhya" userId="f08648d5-c116-438b-b177-bced89d1faa8" providerId="ADAL" clId="{699B68FE-8C20-41D9-9674-1A0C3A8E476B}" dt="2025-01-24T17:05:25.809" v="1" actId="47"/>
        <pc:sldMkLst>
          <pc:docMk/>
          <pc:sldMk cId="1292364588" sldId="34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26E9E1-52B3-4287-A8D4-AE68BFF3F476}" type="datetimeFigureOut">
              <a:rPr lang="en-IN" smtClean="0"/>
              <a:t>24-01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9B6EBC-DC4E-456B-8D29-371AD5A62D5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81421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812CE-3913-4B9B-B7A6-B202BD1EF3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5A0293-513F-48F0-9DD8-6288B1B914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EDD4B-0256-45C2-894B-ED8D5473E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78E27-98F4-4718-8579-B0EBE8040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F46D90-7FD8-452F-A270-3A15B4813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028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C3C87-E00C-47CD-A5C9-6D28558003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A7A005-195F-4BA2-8A12-403C4E74A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249A81-E34F-49BE-A2C3-5CAAF44F2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290B5-6261-4695-85E1-B4693C48B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3CBD2-49BD-4CA7-91FF-231B34B5D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254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DE3BFC-646F-409D-992B-5F8CCE0073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0DF2D-70A7-4AE0-95E1-CA635A68EE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FD7FC1-6828-4D2F-A5F5-F7BAC8EFF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1F741A-1AAF-4455-A5CF-D5FC9A895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315C01-A59D-4EC2-A31A-B8BD552C2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500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6F90F3-80A8-422A-8660-2A1C37AD0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533068-BA2E-4E3C-896C-1978605080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1518D-6B95-4021-99A5-20E927EC8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C939A-56F2-43BD-B949-88E55569C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6A2622-CAB4-44E4-AC93-D2D6606A6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88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3185B-EF72-41E5-99C2-1E35F18C0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B58768-BA8D-4BEB-9CB1-6094BBD581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5A79D8-8472-4100-BBD1-CBED6FD27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12EE-8A45-46FA-9E1C-943857E02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B4697C-502E-4F35-999B-A4360E3BF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807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BC127-14AD-41C7-91AB-E709E7C631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B92C05-80FD-43F5-BD4D-5CAA22BCC9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EA07EE-1D8B-48EB-84A8-BB2A0C7052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8B969B-881D-417A-B227-FBD052270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641F67-1CB8-44E6-83BA-F762687B4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39BF29-E06F-4070-97D2-3456E1465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714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29C86-7C12-4EC7-B613-62ED0C601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BA10D1-B235-4F2B-A3B5-21C18009E9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A96280-9F5C-49F6-8A74-7D7EB3255D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953B23-A60C-450D-8BF9-03E90D0117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F3CA0B-264E-4558-92B6-11C2512899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7647559-B50B-4443-A070-8FA2AD4F4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28A261-2F55-43A4-A411-C7C7CD949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134FD3-CAB4-4335-91BB-4E955CA29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289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354D5-2670-420D-88DD-B58C11E537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7F1E45-3CFC-47E4-88C2-755586C24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DAA789-62B1-4815-8ED5-96F62F0CC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391B6F-B03C-4CA2-8F63-FBD37055E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379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3C4F1B-A1C3-463A-8FE5-40F08A965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F4102C-78A4-4392-BF27-59C43581B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12D0DE-C207-4240-A48E-169235971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317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64D3A-A94D-4D9D-B7C0-2CA46C475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6FA4FF-A8C7-40F0-9AE9-67934E60C5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AB266A-9778-493E-9DB4-408BE4593C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A1E52F-3C7E-4D26-A2E2-35501C4F2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0779A6-A977-43B2-8176-7AE80741C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C2A907-3550-4326-9D85-96B8445A4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143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4A84C-3A66-4D2C-99B9-7800622F3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578EAC-EB10-46A2-97BA-E6908C7D5C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112D90-E215-456D-ABE6-5FCDFD91A1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206DF8-DC9D-4583-8A0C-03B61E5C5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DAF599-1DC2-4CF2-9B35-5E764B89F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05B0AE-345B-44D5-A2DB-5A2CA9351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33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CE4FDE-03FD-4079-B875-476430EAC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6FBE9F-6EE2-4F45-8BF0-1EFC8F499F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5FA44-E8E6-48E4-863A-9A10435CAE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77759-2C95-4B5F-BB52-AF4CDD7FA1F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8C5246-1885-4AA0-872D-2CD555F80D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01D6F8-9EEB-4FFA-A84C-70CC9EEE0F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59001-2E6D-4373-A3D5-1B6BDB44E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901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F7300C1-88A8-AF4A-7614-4EA5325AC076}"/>
              </a:ext>
            </a:extLst>
          </p:cNvPr>
          <p:cNvSpPr txBox="1"/>
          <p:nvPr/>
        </p:nvSpPr>
        <p:spPr>
          <a:xfrm>
            <a:off x="4584102" y="512731"/>
            <a:ext cx="27042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s</a:t>
            </a:r>
            <a:endParaRPr lang="en-I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6B3C7FC-2A4E-7DB0-908A-9485F055D03D}"/>
              </a:ext>
            </a:extLst>
          </p:cNvPr>
          <p:cNvGraphicFramePr>
            <a:graphicFrameLocks noGrp="1"/>
          </p:cNvGraphicFramePr>
          <p:nvPr/>
        </p:nvGraphicFramePr>
        <p:xfrm>
          <a:off x="412376" y="1104643"/>
          <a:ext cx="4921624" cy="2578735"/>
        </p:xfrm>
        <a:graphic>
          <a:graphicData uri="http://schemas.openxmlformats.org/drawingml/2006/table">
            <a:tbl>
              <a:tblPr firstRow="1" firstCol="1" bandRow="1"/>
              <a:tblGrid>
                <a:gridCol w="947920">
                  <a:extLst>
                    <a:ext uri="{9D8B030D-6E8A-4147-A177-3AD203B41FA5}">
                      <a16:colId xmlns:a16="http://schemas.microsoft.com/office/drawing/2014/main" val="838870194"/>
                    </a:ext>
                  </a:extLst>
                </a:gridCol>
                <a:gridCol w="1147970">
                  <a:extLst>
                    <a:ext uri="{9D8B030D-6E8A-4147-A177-3AD203B41FA5}">
                      <a16:colId xmlns:a16="http://schemas.microsoft.com/office/drawing/2014/main" val="4232473642"/>
                    </a:ext>
                  </a:extLst>
                </a:gridCol>
                <a:gridCol w="2825734">
                  <a:extLst>
                    <a:ext uri="{9D8B030D-6E8A-4147-A177-3AD203B41FA5}">
                      <a16:colId xmlns:a16="http://schemas.microsoft.com/office/drawing/2014/main" val="2292413804"/>
                    </a:ext>
                  </a:extLst>
                </a:gridCol>
              </a:tblGrid>
              <a:tr h="2920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nealing 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mperature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imer sequence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23972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β-Actin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 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CAACACAGTGCTGTCTGGTGGTA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ATCGTACTCCTGCTTGCTGATCC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25003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7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 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TATCAGCAAACGCTCACTG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AGTTCACGCACCTGGAATG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0533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F-β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 C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CGGCCGACGATGAGTGGCT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CGGGGCCCATCTCACAGGG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52685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-γ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 C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ACACTGACAAGTCAAAGCCGCACA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AGTCGTTCATCGGGAGCTTGGC</a:t>
                      </a:r>
                      <a:endParaRPr lang="en-IN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865919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9A86179-37D5-226C-01D2-9380EA3953DF}"/>
              </a:ext>
            </a:extLst>
          </p:cNvPr>
          <p:cNvSpPr txBox="1"/>
          <p:nvPr/>
        </p:nvSpPr>
        <p:spPr>
          <a:xfrm>
            <a:off x="274617" y="3707730"/>
            <a:ext cx="60147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:</a:t>
            </a:r>
            <a:r>
              <a:rPr lang="en-US" sz="12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nealing temperatures of different primers used along with their sequence</a:t>
            </a:r>
            <a:endParaRPr lang="en-IN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b="1" dirty="0"/>
          </a:p>
        </p:txBody>
      </p:sp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6" name="Table 5">
                <a:extLst>
                  <a:ext uri="{FF2B5EF4-FFF2-40B4-BE49-F238E27FC236}">
                    <a16:creationId xmlns:a16="http://schemas.microsoft.com/office/drawing/2014/main" id="{763C13F9-59B8-633A-8E18-3E7F8CB6DC31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464819" y="4382355"/>
              <a:ext cx="6079416" cy="1481455"/>
            </p:xfrm>
            <a:graphic>
              <a:graphicData uri="http://schemas.openxmlformats.org/drawingml/2006/table">
                <a:tbl>
                  <a:tblPr firstRow="1" firstCol="1" bandRow="1"/>
                  <a:tblGrid>
                    <a:gridCol w="1525346">
                      <a:extLst>
                        <a:ext uri="{9D8B030D-6E8A-4147-A177-3AD203B41FA5}">
                          <a16:colId xmlns:a16="http://schemas.microsoft.com/office/drawing/2014/main" val="4129947373"/>
                        </a:ext>
                      </a:extLst>
                    </a:gridCol>
                    <a:gridCol w="2043953">
                      <a:extLst>
                        <a:ext uri="{9D8B030D-6E8A-4147-A177-3AD203B41FA5}">
                          <a16:colId xmlns:a16="http://schemas.microsoft.com/office/drawing/2014/main" val="2575894212"/>
                        </a:ext>
                      </a:extLst>
                    </a:gridCol>
                    <a:gridCol w="2510117">
                      <a:extLst>
                        <a:ext uri="{9D8B030D-6E8A-4147-A177-3AD203B41FA5}">
                          <a16:colId xmlns:a16="http://schemas.microsoft.com/office/drawing/2014/main" val="1996452549"/>
                        </a:ext>
                      </a:extLst>
                    </a:gridCol>
                  </a:tblGrid>
                  <a:tr h="153002"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b="1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pecific antibodies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b="1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sotype/ fluorochrome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b="1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rce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2588205198"/>
                      </a:ext>
                    </a:extLst>
                  </a:tr>
                  <a:tr h="0"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3 AF700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1 AF700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193689483"/>
                      </a:ext>
                    </a:extLst>
                  </a:tr>
                  <a:tr h="0"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4 AF488 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1 FITC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4043584208"/>
                      </a:ext>
                    </a:extLst>
                  </a:tr>
                  <a:tr h="0"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8</a:t>
                          </a:r>
                          <a14:m>
                            <m:oMath xmlns:m="http://schemas.openxmlformats.org/officeDocument/2006/math">
                              <m:r>
                                <m:rPr>
                                  <m:sty m:val="p"/>
                                </m:rPr>
                                <a:rPr lang="en-IN" sz="1200" kern="100">
                                  <a:solidFill>
                                    <a:srgbClr val="000000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m:t>α</m:t>
                              </m:r>
                            </m:oMath>
                          </a14:m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PE 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1 PE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7246572"/>
                      </a:ext>
                    </a:extLst>
                  </a:tr>
                  <a:tr h="0"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8 β Biotin 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2 Biotin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US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onjugate: SA PE Texas Red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3071042671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6" name="Table 5">
                <a:extLst>
                  <a:ext uri="{FF2B5EF4-FFF2-40B4-BE49-F238E27FC236}">
                    <a16:creationId xmlns:a16="http://schemas.microsoft.com/office/drawing/2014/main" id="{763C13F9-59B8-633A-8E18-3E7F8CB6DC31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939798969"/>
                  </p:ext>
                </p:extLst>
              </p:nvPr>
            </p:nvGraphicFramePr>
            <p:xfrm>
              <a:off x="464819" y="4382355"/>
              <a:ext cx="6079416" cy="1481455"/>
            </p:xfrm>
            <a:graphic>
              <a:graphicData uri="http://schemas.openxmlformats.org/drawingml/2006/table">
                <a:tbl>
                  <a:tblPr firstRow="1" firstCol="1" bandRow="1"/>
                  <a:tblGrid>
                    <a:gridCol w="1525346">
                      <a:extLst>
                        <a:ext uri="{9D8B030D-6E8A-4147-A177-3AD203B41FA5}">
                          <a16:colId xmlns:a16="http://schemas.microsoft.com/office/drawing/2014/main" val="4129947373"/>
                        </a:ext>
                      </a:extLst>
                    </a:gridCol>
                    <a:gridCol w="2043953">
                      <a:extLst>
                        <a:ext uri="{9D8B030D-6E8A-4147-A177-3AD203B41FA5}">
                          <a16:colId xmlns:a16="http://schemas.microsoft.com/office/drawing/2014/main" val="2575894212"/>
                        </a:ext>
                      </a:extLst>
                    </a:gridCol>
                    <a:gridCol w="2510117">
                      <a:extLst>
                        <a:ext uri="{9D8B030D-6E8A-4147-A177-3AD203B41FA5}">
                          <a16:colId xmlns:a16="http://schemas.microsoft.com/office/drawing/2014/main" val="1996452549"/>
                        </a:ext>
                      </a:extLst>
                    </a:gridCol>
                  </a:tblGrid>
                  <a:tr h="241427"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b="1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pecific antibodies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b="1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sotype/ fluorochrome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b="1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rce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2588205198"/>
                      </a:ext>
                    </a:extLst>
                  </a:tr>
                  <a:tr h="241427"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3 AF700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1 AF700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193689483"/>
                      </a:ext>
                    </a:extLst>
                  </a:tr>
                  <a:tr h="241427"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4 AF488 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1 FITC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4043584208"/>
                      </a:ext>
                    </a:extLst>
                  </a:tr>
                  <a:tr h="241427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0" t="-300000" r="-300000" b="-2525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1 PE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7246572"/>
                      </a:ext>
                    </a:extLst>
                  </a:tr>
                  <a:tr h="515747"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D8 β Biotin </a:t>
                          </a:r>
                          <a:endParaRPr lang="en-IN" sz="1200" kern="10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ouse IgG2 Biotin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US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onjugate: SA PE Texas Red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tc>
                      <a:txBody>
                        <a:bodyPr/>
                        <a:lstStyle/>
                        <a:p>
                          <a:pPr fontAlgn="base">
                            <a:lnSpc>
                              <a:spcPct val="150000"/>
                            </a:lnSpc>
                          </a:pPr>
                          <a:r>
                            <a:rPr lang="en-IN" sz="1200" kern="1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outhern Biotech, Birmingham, AL</a:t>
                          </a:r>
                          <a:endParaRPr lang="en-IN" sz="1200" kern="100" dirty="0"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>
                        <a:lnL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rgbClr val="000000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noFill/>
                      </a:tcPr>
                    </a:tc>
                    <a:extLst>
                      <a:ext uri="{0D108BD9-81ED-4DB2-BD59-A6C34878D82A}">
                        <a16:rowId xmlns:a16="http://schemas.microsoft.com/office/drawing/2014/main" val="3071042671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8" name="TextBox 7">
            <a:extLst>
              <a:ext uri="{FF2B5EF4-FFF2-40B4-BE49-F238E27FC236}">
                <a16:creationId xmlns:a16="http://schemas.microsoft.com/office/drawing/2014/main" id="{316F96AE-952D-5F35-44CE-AD45DBA766F7}"/>
              </a:ext>
            </a:extLst>
          </p:cNvPr>
          <p:cNvSpPr txBox="1"/>
          <p:nvPr/>
        </p:nvSpPr>
        <p:spPr>
          <a:xfrm>
            <a:off x="350518" y="6021337"/>
            <a:ext cx="6096000" cy="336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2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ntibodies used in the Flow cytometry</a:t>
            </a:r>
            <a:endParaRPr lang="en-IN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13B04E34-0448-10BC-A205-29D19F40B86C}"/>
              </a:ext>
            </a:extLst>
          </p:cNvPr>
          <p:cNvGraphicFramePr>
            <a:graphicFrameLocks noGrp="1"/>
          </p:cNvGraphicFramePr>
          <p:nvPr/>
        </p:nvGraphicFramePr>
        <p:xfrm>
          <a:off x="5615044" y="1187206"/>
          <a:ext cx="6299050" cy="1461389"/>
        </p:xfrm>
        <a:graphic>
          <a:graphicData uri="http://schemas.openxmlformats.org/drawingml/2006/table">
            <a:tbl>
              <a:tblPr firstRow="1" firstCol="1" bandRow="1"/>
              <a:tblGrid>
                <a:gridCol w="1792941">
                  <a:extLst>
                    <a:ext uri="{9D8B030D-6E8A-4147-A177-3AD203B41FA5}">
                      <a16:colId xmlns:a16="http://schemas.microsoft.com/office/drawing/2014/main" val="2512016284"/>
                    </a:ext>
                  </a:extLst>
                </a:gridCol>
                <a:gridCol w="2363545">
                  <a:extLst>
                    <a:ext uri="{9D8B030D-6E8A-4147-A177-3AD203B41FA5}">
                      <a16:colId xmlns:a16="http://schemas.microsoft.com/office/drawing/2014/main" val="2054277412"/>
                    </a:ext>
                  </a:extLst>
                </a:gridCol>
                <a:gridCol w="2142564">
                  <a:extLst>
                    <a:ext uri="{9D8B030D-6E8A-4147-A177-3AD203B41FA5}">
                      <a16:colId xmlns:a16="http://schemas.microsoft.com/office/drawing/2014/main" val="299463865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ecific antibodies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sotype/fluorochrome</a:t>
                      </a:r>
                      <a:endParaRPr lang="en-IN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89121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 AF700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fontAlgn="base"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 IgG1 AF700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uthern Biotech, Birmingham, AL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10474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 1-PE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fontAlgn="base"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 IgG1 PE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uthern Biotech, Birmingham, AL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60481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nocyte/Macrophage FITC</a:t>
                      </a:r>
                      <a:endParaRPr lang="en-IN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fontAlgn="base"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 IgG1 FITC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uthern Biotech, Birmingham, AL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8969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Rγδ- Biotin</a:t>
                      </a:r>
                      <a:endParaRPr lang="en-IN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fontAlgn="base"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 IgG1 Biotin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fontAlgn="base">
                        <a:lnSpc>
                          <a:spcPct val="150000"/>
                        </a:lnSpc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jugate: SA PE Texas red (1:750)</a:t>
                      </a:r>
                      <a:endParaRPr lang="en-IN" sz="12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IN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uthern Biotech, Birmingham, AL</a:t>
                      </a:r>
                      <a:endParaRPr lang="en-IN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6981302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A803D4DF-F07C-BC45-AE77-9ED8116FEEB0}"/>
              </a:ext>
            </a:extLst>
          </p:cNvPr>
          <p:cNvSpPr txBox="1"/>
          <p:nvPr/>
        </p:nvSpPr>
        <p:spPr>
          <a:xfrm>
            <a:off x="5488043" y="2601163"/>
            <a:ext cx="6106160" cy="336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3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ntibodies used in the Flow cytometry - Panel 2</a:t>
            </a:r>
            <a:endParaRPr lang="en-IN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1433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D88BD51-C8C2-5B75-26BA-B89089D21621}"/>
              </a:ext>
            </a:extLst>
          </p:cNvPr>
          <p:cNvSpPr txBox="1"/>
          <p:nvPr/>
        </p:nvSpPr>
        <p:spPr>
          <a:xfrm>
            <a:off x="5157097" y="864063"/>
            <a:ext cx="23158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SDS-PAGE gel image of Coomassie Brilliant Blue stained extracted outer membrane proteins (OMPs) and Flagella (FLA) of Salmonella Enteritidis.  was assessed using SDS-PAGE. The major bands for OMP were observed at around 52kDa, 37kDa and 28 kDa. For Flagella, the major band observed was approximately at around 52 kDa.&#10;">
            <a:extLst>
              <a:ext uri="{FF2B5EF4-FFF2-40B4-BE49-F238E27FC236}">
                <a16:creationId xmlns:a16="http://schemas.microsoft.com/office/drawing/2014/main" id="{5C296DBD-7E2F-8951-DA3A-1D317661FA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8183" y="1112762"/>
            <a:ext cx="2315845" cy="304990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085A67C-A4C2-E7A8-D193-2BDC4140ACEB}"/>
              </a:ext>
            </a:extLst>
          </p:cNvPr>
          <p:cNvSpPr txBox="1"/>
          <p:nvPr/>
        </p:nvSpPr>
        <p:spPr>
          <a:xfrm>
            <a:off x="4101138" y="4091230"/>
            <a:ext cx="442776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: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DS-PAGE gel image of Coomassie Brilliant Blue stained extracted outer membrane proteins (OMP) and Flagella (FLA)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teritidis. Lane 3 of Gel 1 and Lane 4 of Gel 2: OMP and FLA used in this vaccine study. Gels 1 and 2: Lane 1: Mol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rker; Gel 1 Lane 2 and Gel 2 Lane 3: Referenc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teritidis OMP and FLA. Each lane was loaded with 10 µg of protein.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202055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08</TotalTime>
  <Words>287</Words>
  <Application>Microsoft Office PowerPoint</Application>
  <PresentationFormat>Widescreen</PresentationFormat>
  <Paragraphs>5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resh, Raksha</dc:creator>
  <cp:lastModifiedBy>Gourapura, Aradhya</cp:lastModifiedBy>
  <cp:revision>34</cp:revision>
  <dcterms:created xsi:type="dcterms:W3CDTF">2024-05-06T12:41:41Z</dcterms:created>
  <dcterms:modified xsi:type="dcterms:W3CDTF">2025-01-24T17:48:16Z</dcterms:modified>
</cp:coreProperties>
</file>